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554368-D1DB-4658-B8E3-FC2B717BD7D7}" type="slidenum">
              <a:rPr b="0" lang="zh-CN" sz="1200" spc="-1" strike="noStrike">
                <a:solidFill>
                  <a:srgbClr val="000000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22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25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028A07-164E-4B46-A710-FC35B5B00ECE}" type="slidenum">
              <a:rPr b="0" lang="zh-CN" sz="1200" spc="-1" strike="noStrike">
                <a:solidFill>
                  <a:srgbClr val="000000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22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28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368333-FCFE-40E7-9900-D352F5874ED5}" type="slidenum">
              <a:rPr b="0" lang="zh-CN" sz="1200" spc="-1" strike="noStrike">
                <a:solidFill>
                  <a:srgbClr val="000000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00275-F2EB-4CBA-85D2-94A9509597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9312A3-4A52-47F4-9E3E-4DEFF16534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05D68-7B06-4778-88E8-8724773659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DACAC-2358-4AC9-AF80-E8B6160CFE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804FF-E9AB-40DE-8419-F5BE815D9F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FD0FD-5327-42AF-A87E-6375303503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48D45-4571-4785-96FE-33F40FCC20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C01730-6C67-4A1A-A123-8D4BA6C8F0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ADF55-DD8C-4018-A153-A6C297E13B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5061E-57A2-4974-9285-7C3624BECE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6D125-972E-431F-876E-9CC2F2F23D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A2D807-1BB9-4B4E-BB1E-A21690D701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9C778F-3C66-463E-AEAE-23722BEF23C9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image" Target="../media/image17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5.png"/><Relationship Id="rId9" Type="http://schemas.openxmlformats.org/officeDocument/2006/relationships/image" Target="../media/image26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矩形 12"/>
          <p:cNvSpPr/>
          <p:nvPr/>
        </p:nvSpPr>
        <p:spPr>
          <a:xfrm>
            <a:off x="0" y="27000"/>
            <a:ext cx="10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1C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grpSp>
        <p:nvGrpSpPr>
          <p:cNvPr id="49" name="组合 55"/>
          <p:cNvGrpSpPr/>
          <p:nvPr/>
        </p:nvGrpSpPr>
        <p:grpSpPr>
          <a:xfrm>
            <a:off x="1487520" y="1413000"/>
            <a:ext cx="7010280" cy="1647000"/>
            <a:chOff x="1487520" y="1413000"/>
            <a:chExt cx="7010280" cy="1647000"/>
          </a:xfrm>
        </p:grpSpPr>
        <p:pic>
          <p:nvPicPr>
            <p:cNvPr id="50" name="图片 9" descr=""/>
            <p:cNvPicPr/>
            <p:nvPr/>
          </p:nvPicPr>
          <p:blipFill>
            <a:blip r:embed="rId1"/>
            <a:stretch/>
          </p:blipFill>
          <p:spPr>
            <a:xfrm>
              <a:off x="1487520" y="1413000"/>
              <a:ext cx="2200680" cy="164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图片 10" descr=""/>
            <p:cNvPicPr/>
            <p:nvPr/>
          </p:nvPicPr>
          <p:blipFill>
            <a:blip r:embed="rId2"/>
            <a:stretch/>
          </p:blipFill>
          <p:spPr>
            <a:xfrm>
              <a:off x="3889080" y="1413000"/>
              <a:ext cx="2206800" cy="164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图片 11" descr=""/>
            <p:cNvPicPr/>
            <p:nvPr/>
          </p:nvPicPr>
          <p:blipFill>
            <a:blip r:embed="rId3"/>
            <a:stretch/>
          </p:blipFill>
          <p:spPr>
            <a:xfrm>
              <a:off x="6297120" y="1413000"/>
              <a:ext cx="2200680" cy="164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文本框 14"/>
            <p:cNvSpPr/>
            <p:nvPr/>
          </p:nvSpPr>
          <p:spPr>
            <a:xfrm rot="18592800">
              <a:off x="2196360" y="2429640"/>
              <a:ext cx="79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 PBS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4" name="文本框 15"/>
            <p:cNvSpPr/>
            <p:nvPr/>
          </p:nvSpPr>
          <p:spPr>
            <a:xfrm rot="18592800">
              <a:off x="1643760" y="2383200"/>
              <a:ext cx="650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5" name="文本框 16"/>
            <p:cNvSpPr/>
            <p:nvPr/>
          </p:nvSpPr>
          <p:spPr>
            <a:xfrm rot="18592800">
              <a:off x="2571840" y="2436840"/>
              <a:ext cx="812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 Irisin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6" name="文本框 17"/>
            <p:cNvSpPr/>
            <p:nvPr/>
          </p:nvSpPr>
          <p:spPr>
            <a:xfrm rot="18592800">
              <a:off x="1804320" y="2454840"/>
              <a:ext cx="85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7" name="文本框 13"/>
            <p:cNvSpPr/>
            <p:nvPr/>
          </p:nvSpPr>
          <p:spPr>
            <a:xfrm>
              <a:off x="1820880" y="1527840"/>
              <a:ext cx="1239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GSDMD-N(p31)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8" name="文本框 45"/>
            <p:cNvSpPr/>
            <p:nvPr/>
          </p:nvSpPr>
          <p:spPr>
            <a:xfrm>
              <a:off x="4120560" y="1527840"/>
              <a:ext cx="1239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-C</a:t>
              </a:r>
              <a:r>
                <a:rPr b="1" lang="zh-CN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aspase-1</a:t>
              </a: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(p20)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9" name="文本框 46"/>
            <p:cNvSpPr/>
            <p:nvPr/>
          </p:nvSpPr>
          <p:spPr>
            <a:xfrm>
              <a:off x="6521040" y="1527840"/>
              <a:ext cx="1239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β</a:t>
              </a: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0" name="文本框 47"/>
            <p:cNvSpPr/>
            <p:nvPr/>
          </p:nvSpPr>
          <p:spPr>
            <a:xfrm rot="18592800">
              <a:off x="4774680" y="2489400"/>
              <a:ext cx="79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 PBS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1" name="文本框 48"/>
            <p:cNvSpPr/>
            <p:nvPr/>
          </p:nvSpPr>
          <p:spPr>
            <a:xfrm rot="18592800">
              <a:off x="4239720" y="2445120"/>
              <a:ext cx="65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2" name="文本框 49"/>
            <p:cNvSpPr/>
            <p:nvPr/>
          </p:nvSpPr>
          <p:spPr>
            <a:xfrm rot="18592800">
              <a:off x="5057640" y="2507040"/>
              <a:ext cx="812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 Irisin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3" name="文本框 50"/>
            <p:cNvSpPr/>
            <p:nvPr/>
          </p:nvSpPr>
          <p:spPr>
            <a:xfrm rot="18592800">
              <a:off x="4399920" y="2525040"/>
              <a:ext cx="85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4" name="文本框 51"/>
            <p:cNvSpPr/>
            <p:nvPr/>
          </p:nvSpPr>
          <p:spPr>
            <a:xfrm rot="18592800">
              <a:off x="7112160" y="2480400"/>
              <a:ext cx="79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 PBS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5" name="文本框 52"/>
            <p:cNvSpPr/>
            <p:nvPr/>
          </p:nvSpPr>
          <p:spPr>
            <a:xfrm rot="18592800">
              <a:off x="6531840" y="2432880"/>
              <a:ext cx="65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6" name="文本框 53"/>
            <p:cNvSpPr/>
            <p:nvPr/>
          </p:nvSpPr>
          <p:spPr>
            <a:xfrm rot="18592800">
              <a:off x="7448400" y="2494440"/>
              <a:ext cx="812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 Irisin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7" name="文本框 54"/>
            <p:cNvSpPr/>
            <p:nvPr/>
          </p:nvSpPr>
          <p:spPr>
            <a:xfrm rot="18592800">
              <a:off x="6692400" y="2512440"/>
              <a:ext cx="85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组合 32"/>
          <p:cNvGrpSpPr/>
          <p:nvPr/>
        </p:nvGrpSpPr>
        <p:grpSpPr>
          <a:xfrm>
            <a:off x="1415880" y="4021200"/>
            <a:ext cx="2397240" cy="1742040"/>
            <a:chOff x="1415880" y="4021200"/>
            <a:chExt cx="2397240" cy="1742040"/>
          </a:xfrm>
        </p:grpSpPr>
        <p:pic>
          <p:nvPicPr>
            <p:cNvPr id="69" name="图片 4" descr=""/>
            <p:cNvPicPr/>
            <p:nvPr/>
          </p:nvPicPr>
          <p:blipFill>
            <a:blip r:embed="rId1"/>
            <a:srcRect l="21539" t="33096" r="36244" b="40983"/>
            <a:stretch/>
          </p:blipFill>
          <p:spPr>
            <a:xfrm>
              <a:off x="1415880" y="4021200"/>
              <a:ext cx="2397240" cy="1200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文本框 7"/>
            <p:cNvSpPr/>
            <p:nvPr/>
          </p:nvSpPr>
          <p:spPr>
            <a:xfrm rot="18871200">
              <a:off x="1560240" y="4932360"/>
              <a:ext cx="701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1" name="文本框 8"/>
            <p:cNvSpPr/>
            <p:nvPr/>
          </p:nvSpPr>
          <p:spPr>
            <a:xfrm rot="18871200">
              <a:off x="1928520" y="4959000"/>
              <a:ext cx="843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2" name="文本框 9"/>
            <p:cNvSpPr/>
            <p:nvPr/>
          </p:nvSpPr>
          <p:spPr>
            <a:xfrm rot="18871200">
              <a:off x="2211840" y="5003280"/>
              <a:ext cx="96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3" name="文本框 10"/>
            <p:cNvSpPr/>
            <p:nvPr/>
          </p:nvSpPr>
          <p:spPr>
            <a:xfrm rot="18871200">
              <a:off x="2440800" y="5130720"/>
              <a:ext cx="1222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Irisin+ATP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4" name="文本框 12"/>
            <p:cNvSpPr/>
            <p:nvPr/>
          </p:nvSpPr>
          <p:spPr>
            <a:xfrm>
              <a:off x="2126520" y="4052520"/>
              <a:ext cx="92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β-</a:t>
              </a: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actin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75" name="组合 35"/>
          <p:cNvGrpSpPr/>
          <p:nvPr/>
        </p:nvGrpSpPr>
        <p:grpSpPr>
          <a:xfrm>
            <a:off x="1425600" y="873000"/>
            <a:ext cx="2387520" cy="1544040"/>
            <a:chOff x="1425600" y="873000"/>
            <a:chExt cx="2387520" cy="1544040"/>
          </a:xfrm>
        </p:grpSpPr>
        <p:pic>
          <p:nvPicPr>
            <p:cNvPr id="76" name="图片 5" descr=""/>
            <p:cNvPicPr/>
            <p:nvPr/>
          </p:nvPicPr>
          <p:blipFill>
            <a:blip r:embed="rId2"/>
            <a:srcRect l="24332" t="40746" r="33626" b="33958"/>
            <a:stretch/>
          </p:blipFill>
          <p:spPr>
            <a:xfrm>
              <a:off x="1425600" y="873000"/>
              <a:ext cx="2387520" cy="117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文本框 11"/>
            <p:cNvSpPr/>
            <p:nvPr/>
          </p:nvSpPr>
          <p:spPr>
            <a:xfrm>
              <a:off x="2136240" y="873000"/>
              <a:ext cx="920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GSDMD-N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8" name="文本框 7"/>
            <p:cNvSpPr/>
            <p:nvPr/>
          </p:nvSpPr>
          <p:spPr>
            <a:xfrm rot="18871200">
              <a:off x="1532880" y="1609560"/>
              <a:ext cx="701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9" name="文本框 8"/>
            <p:cNvSpPr/>
            <p:nvPr/>
          </p:nvSpPr>
          <p:spPr>
            <a:xfrm rot="18871200">
              <a:off x="1823400" y="1664640"/>
              <a:ext cx="843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0" name="文本框 9"/>
            <p:cNvSpPr/>
            <p:nvPr/>
          </p:nvSpPr>
          <p:spPr>
            <a:xfrm rot="18871200">
              <a:off x="2151000" y="1682640"/>
              <a:ext cx="96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1" name="文本框 10"/>
            <p:cNvSpPr/>
            <p:nvPr/>
          </p:nvSpPr>
          <p:spPr>
            <a:xfrm rot="18871200">
              <a:off x="2354400" y="1784520"/>
              <a:ext cx="1222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Irisin+ATP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82" name="组合 36"/>
          <p:cNvGrpSpPr/>
          <p:nvPr/>
        </p:nvGrpSpPr>
        <p:grpSpPr>
          <a:xfrm>
            <a:off x="4165560" y="865080"/>
            <a:ext cx="2387520" cy="1513800"/>
            <a:chOff x="4165560" y="865080"/>
            <a:chExt cx="2387520" cy="1513800"/>
          </a:xfrm>
        </p:grpSpPr>
        <p:pic>
          <p:nvPicPr>
            <p:cNvPr id="83" name="图片 1" descr=""/>
            <p:cNvPicPr/>
            <p:nvPr/>
          </p:nvPicPr>
          <p:blipFill>
            <a:blip r:embed="rId3"/>
            <a:srcRect l="31606" t="40767" r="26353" b="33635"/>
            <a:stretch/>
          </p:blipFill>
          <p:spPr>
            <a:xfrm>
              <a:off x="4165560" y="865080"/>
              <a:ext cx="2387520" cy="1186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文本框 7"/>
            <p:cNvSpPr/>
            <p:nvPr/>
          </p:nvSpPr>
          <p:spPr>
            <a:xfrm rot="18871200">
              <a:off x="4375800" y="1775520"/>
              <a:ext cx="701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5" name="文本框 8"/>
            <p:cNvSpPr/>
            <p:nvPr/>
          </p:nvSpPr>
          <p:spPr>
            <a:xfrm rot="18871200">
              <a:off x="4659120" y="1792440"/>
              <a:ext cx="843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6" name="文本框 9"/>
            <p:cNvSpPr/>
            <p:nvPr/>
          </p:nvSpPr>
          <p:spPr>
            <a:xfrm rot="18871200">
              <a:off x="4942800" y="1837080"/>
              <a:ext cx="96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7" name="文本框 29"/>
            <p:cNvSpPr/>
            <p:nvPr/>
          </p:nvSpPr>
          <p:spPr>
            <a:xfrm>
              <a:off x="4961520" y="872280"/>
              <a:ext cx="920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NLRP3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88" name="组合 33"/>
          <p:cNvGrpSpPr/>
          <p:nvPr/>
        </p:nvGrpSpPr>
        <p:grpSpPr>
          <a:xfrm>
            <a:off x="1425600" y="2432160"/>
            <a:ext cx="2397240" cy="1391760"/>
            <a:chOff x="1425600" y="2432160"/>
            <a:chExt cx="2397240" cy="1391760"/>
          </a:xfrm>
        </p:grpSpPr>
        <p:pic>
          <p:nvPicPr>
            <p:cNvPr id="89" name="图片 2" descr=""/>
            <p:cNvPicPr/>
            <p:nvPr/>
          </p:nvPicPr>
          <p:blipFill>
            <a:blip r:embed="rId4"/>
            <a:srcRect l="28654" t="42340" r="29129" b="31739"/>
            <a:stretch/>
          </p:blipFill>
          <p:spPr>
            <a:xfrm>
              <a:off x="1425600" y="2432160"/>
              <a:ext cx="2397240" cy="1201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0" name="文本框 13"/>
            <p:cNvSpPr/>
            <p:nvPr/>
          </p:nvSpPr>
          <p:spPr>
            <a:xfrm rot="18871200">
              <a:off x="1569960" y="3210120"/>
              <a:ext cx="701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1" name="文本框 14"/>
            <p:cNvSpPr/>
            <p:nvPr/>
          </p:nvSpPr>
          <p:spPr>
            <a:xfrm rot="18871200">
              <a:off x="1847880" y="3237480"/>
              <a:ext cx="843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2" name="文本框 15"/>
            <p:cNvSpPr/>
            <p:nvPr/>
          </p:nvSpPr>
          <p:spPr>
            <a:xfrm rot="18871200">
              <a:off x="2134800" y="3282120"/>
              <a:ext cx="968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3" name="文本框 30"/>
            <p:cNvSpPr/>
            <p:nvPr/>
          </p:nvSpPr>
          <p:spPr>
            <a:xfrm>
              <a:off x="2136240" y="2475720"/>
              <a:ext cx="92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ASC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94" name="组合 34"/>
          <p:cNvGrpSpPr/>
          <p:nvPr/>
        </p:nvGrpSpPr>
        <p:grpSpPr>
          <a:xfrm>
            <a:off x="4213080" y="2432160"/>
            <a:ext cx="2340000" cy="1879920"/>
            <a:chOff x="4213080" y="2432160"/>
            <a:chExt cx="2340000" cy="1879920"/>
          </a:xfrm>
        </p:grpSpPr>
        <p:pic>
          <p:nvPicPr>
            <p:cNvPr id="95" name="图片 3" descr=""/>
            <p:cNvPicPr/>
            <p:nvPr/>
          </p:nvPicPr>
          <p:blipFill>
            <a:blip r:embed="rId5"/>
            <a:srcRect l="22804" t="39323" r="34891" b="33075"/>
            <a:stretch/>
          </p:blipFill>
          <p:spPr>
            <a:xfrm>
              <a:off x="4213080" y="2432160"/>
              <a:ext cx="2340000" cy="1245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文本框 7"/>
            <p:cNvSpPr/>
            <p:nvPr/>
          </p:nvSpPr>
          <p:spPr>
            <a:xfrm rot="18871200">
              <a:off x="4387680" y="3517560"/>
              <a:ext cx="701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7" name="文本框 8"/>
            <p:cNvSpPr/>
            <p:nvPr/>
          </p:nvSpPr>
          <p:spPr>
            <a:xfrm rot="18871200">
              <a:off x="4657680" y="3544200"/>
              <a:ext cx="843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8" name="文本框 9"/>
            <p:cNvSpPr/>
            <p:nvPr/>
          </p:nvSpPr>
          <p:spPr>
            <a:xfrm rot="18871200">
              <a:off x="4898880" y="3561840"/>
              <a:ext cx="96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9" name="文本框 10"/>
            <p:cNvSpPr/>
            <p:nvPr/>
          </p:nvSpPr>
          <p:spPr>
            <a:xfrm rot="18871200">
              <a:off x="5092560" y="3679560"/>
              <a:ext cx="1222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HG+Irisin+ATP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0" name="文本框 29"/>
            <p:cNvSpPr/>
            <p:nvPr/>
          </p:nvSpPr>
          <p:spPr>
            <a:xfrm>
              <a:off x="4961160" y="2475720"/>
              <a:ext cx="92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-Caspase-1</a:t>
              </a:r>
              <a:endParaRPr b="0" lang="en-US" sz="10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sp>
        <p:nvSpPr>
          <p:cNvPr id="101" name="文本框 16"/>
          <p:cNvSpPr/>
          <p:nvPr/>
        </p:nvSpPr>
        <p:spPr>
          <a:xfrm rot="18871200">
            <a:off x="2384640" y="3466800"/>
            <a:ext cx="122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ATP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02" name="文本框 10"/>
          <p:cNvSpPr/>
          <p:nvPr/>
        </p:nvSpPr>
        <p:spPr>
          <a:xfrm rot="18871200">
            <a:off x="5105160" y="1958760"/>
            <a:ext cx="122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ATP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03" name="矩形 37"/>
          <p:cNvSpPr/>
          <p:nvPr/>
        </p:nvSpPr>
        <p:spPr>
          <a:xfrm>
            <a:off x="0" y="27000"/>
            <a:ext cx="10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2E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矩形 1"/>
          <p:cNvSpPr/>
          <p:nvPr/>
        </p:nvSpPr>
        <p:spPr>
          <a:xfrm>
            <a:off x="0" y="27000"/>
            <a:ext cx="10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3E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5" name="图片 13" descr=""/>
          <p:cNvPicPr/>
          <p:nvPr/>
        </p:nvPicPr>
        <p:blipFill>
          <a:blip r:embed="rId1"/>
          <a:srcRect l="22154" t="22280" r="28479" b="23508"/>
          <a:stretch/>
        </p:blipFill>
        <p:spPr>
          <a:xfrm>
            <a:off x="1830240" y="222120"/>
            <a:ext cx="2001960" cy="1793880"/>
          </a:xfrm>
          <a:prstGeom prst="rect">
            <a:avLst/>
          </a:prstGeom>
          <a:ln w="0">
            <a:noFill/>
          </a:ln>
        </p:spPr>
      </p:pic>
      <p:pic>
        <p:nvPicPr>
          <p:cNvPr id="106" name="图片 14" descr=""/>
          <p:cNvPicPr/>
          <p:nvPr/>
        </p:nvPicPr>
        <p:blipFill>
          <a:blip r:embed="rId2"/>
          <a:srcRect l="16427" t="22797" r="34206" b="22991"/>
          <a:stretch/>
        </p:blipFill>
        <p:spPr>
          <a:xfrm>
            <a:off x="4052880" y="222120"/>
            <a:ext cx="2003400" cy="1793880"/>
          </a:xfrm>
          <a:prstGeom prst="rect">
            <a:avLst/>
          </a:prstGeom>
          <a:ln w="0">
            <a:noFill/>
          </a:ln>
        </p:spPr>
      </p:pic>
      <p:pic>
        <p:nvPicPr>
          <p:cNvPr id="107" name="图片 15" descr=""/>
          <p:cNvPicPr/>
          <p:nvPr/>
        </p:nvPicPr>
        <p:blipFill>
          <a:blip r:embed="rId3"/>
          <a:srcRect l="13229" t="27947" r="37403" b="17841"/>
          <a:stretch/>
        </p:blipFill>
        <p:spPr>
          <a:xfrm>
            <a:off x="6272280" y="222120"/>
            <a:ext cx="2001600" cy="1793880"/>
          </a:xfrm>
          <a:prstGeom prst="rect">
            <a:avLst/>
          </a:prstGeom>
          <a:ln w="0">
            <a:noFill/>
          </a:ln>
        </p:spPr>
      </p:pic>
      <p:pic>
        <p:nvPicPr>
          <p:cNvPr id="108" name="图片 17" descr=""/>
          <p:cNvPicPr/>
          <p:nvPr/>
        </p:nvPicPr>
        <p:blipFill>
          <a:blip r:embed="rId4"/>
          <a:srcRect l="15829" t="21482" r="34399" b="23788"/>
          <a:stretch/>
        </p:blipFill>
        <p:spPr>
          <a:xfrm>
            <a:off x="1830240" y="2259000"/>
            <a:ext cx="2019600" cy="1809720"/>
          </a:xfrm>
          <a:prstGeom prst="rect">
            <a:avLst/>
          </a:prstGeom>
          <a:ln w="0">
            <a:noFill/>
          </a:ln>
        </p:spPr>
      </p:pic>
      <p:pic>
        <p:nvPicPr>
          <p:cNvPr id="109" name="图片 18" descr=""/>
          <p:cNvPicPr/>
          <p:nvPr/>
        </p:nvPicPr>
        <p:blipFill>
          <a:blip r:embed="rId5"/>
          <a:srcRect l="24895" t="22107" r="25808" b="23853"/>
          <a:stretch/>
        </p:blipFill>
        <p:spPr>
          <a:xfrm>
            <a:off x="4062240" y="2259000"/>
            <a:ext cx="2000520" cy="1787400"/>
          </a:xfrm>
          <a:prstGeom prst="rect">
            <a:avLst/>
          </a:prstGeom>
          <a:ln w="0">
            <a:noFill/>
          </a:ln>
        </p:spPr>
      </p:pic>
      <p:pic>
        <p:nvPicPr>
          <p:cNvPr id="110" name="图片 19" descr=""/>
          <p:cNvPicPr/>
          <p:nvPr/>
        </p:nvPicPr>
        <p:blipFill>
          <a:blip r:embed="rId6"/>
          <a:srcRect l="19325" t="29476" r="31395" b="16484"/>
          <a:stretch/>
        </p:blipFill>
        <p:spPr>
          <a:xfrm>
            <a:off x="6275520" y="2259000"/>
            <a:ext cx="1998360" cy="1787400"/>
          </a:xfrm>
          <a:prstGeom prst="rect">
            <a:avLst/>
          </a:prstGeom>
          <a:ln w="0">
            <a:noFill/>
          </a:ln>
        </p:spPr>
      </p:pic>
      <p:pic>
        <p:nvPicPr>
          <p:cNvPr id="111" name="图片 20" descr=""/>
          <p:cNvPicPr/>
          <p:nvPr/>
        </p:nvPicPr>
        <p:blipFill>
          <a:blip r:embed="rId7"/>
          <a:srcRect l="24473" t="25275" r="25966" b="20685"/>
          <a:stretch/>
        </p:blipFill>
        <p:spPr>
          <a:xfrm>
            <a:off x="1830240" y="4280040"/>
            <a:ext cx="2011680" cy="1788840"/>
          </a:xfrm>
          <a:prstGeom prst="rect">
            <a:avLst/>
          </a:prstGeom>
          <a:ln w="0">
            <a:noFill/>
          </a:ln>
        </p:spPr>
      </p:pic>
      <p:pic>
        <p:nvPicPr>
          <p:cNvPr id="112" name="图片 21" descr=""/>
          <p:cNvPicPr/>
          <p:nvPr/>
        </p:nvPicPr>
        <p:blipFill>
          <a:blip r:embed="rId8"/>
          <a:srcRect l="18465" t="20534" r="32010" b="25426"/>
          <a:stretch/>
        </p:blipFill>
        <p:spPr>
          <a:xfrm>
            <a:off x="4048200" y="4311720"/>
            <a:ext cx="2009880" cy="1787400"/>
          </a:xfrm>
          <a:prstGeom prst="rect">
            <a:avLst/>
          </a:prstGeom>
          <a:ln w="0">
            <a:noFill/>
          </a:ln>
        </p:spPr>
      </p:pic>
      <p:pic>
        <p:nvPicPr>
          <p:cNvPr id="113" name="图片 22" descr=""/>
          <p:cNvPicPr/>
          <p:nvPr/>
        </p:nvPicPr>
        <p:blipFill>
          <a:blip r:embed="rId9"/>
          <a:srcRect l="22751" t="20534" r="27706" b="25426"/>
          <a:stretch/>
        </p:blipFill>
        <p:spPr>
          <a:xfrm>
            <a:off x="6264360" y="4311720"/>
            <a:ext cx="2009520" cy="1787400"/>
          </a:xfrm>
          <a:prstGeom prst="rect">
            <a:avLst/>
          </a:prstGeom>
          <a:ln w="0">
            <a:noFill/>
          </a:ln>
        </p:spPr>
      </p:pic>
      <p:sp>
        <p:nvSpPr>
          <p:cNvPr id="114" name="文本框 3"/>
          <p:cNvSpPr/>
          <p:nvPr/>
        </p:nvSpPr>
        <p:spPr>
          <a:xfrm>
            <a:off x="4592520" y="434196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GSDMD-N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5" name="文本框 4"/>
          <p:cNvSpPr/>
          <p:nvPr/>
        </p:nvSpPr>
        <p:spPr>
          <a:xfrm>
            <a:off x="4592520" y="230652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NLRP3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6" name="文本框 5"/>
          <p:cNvSpPr/>
          <p:nvPr/>
        </p:nvSpPr>
        <p:spPr>
          <a:xfrm>
            <a:off x="6810480" y="2306520"/>
            <a:ext cx="91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ASC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7" name="文本框 29"/>
          <p:cNvSpPr/>
          <p:nvPr/>
        </p:nvSpPr>
        <p:spPr>
          <a:xfrm>
            <a:off x="2305080" y="434196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-Caspase-1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8" name="文本框 7"/>
          <p:cNvSpPr/>
          <p:nvPr/>
        </p:nvSpPr>
        <p:spPr>
          <a:xfrm>
            <a:off x="6810480" y="4341960"/>
            <a:ext cx="91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9" name="文本框 8"/>
          <p:cNvSpPr/>
          <p:nvPr/>
        </p:nvSpPr>
        <p:spPr>
          <a:xfrm>
            <a:off x="2305080" y="230652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TrX1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0" name="文本框 9"/>
          <p:cNvSpPr/>
          <p:nvPr/>
        </p:nvSpPr>
        <p:spPr>
          <a:xfrm>
            <a:off x="6810480" y="210960"/>
            <a:ext cx="91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TXNIP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1" name="文本框 10"/>
          <p:cNvSpPr/>
          <p:nvPr/>
        </p:nvSpPr>
        <p:spPr>
          <a:xfrm>
            <a:off x="4592520" y="21096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Lamin B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2" name="文本框 11"/>
          <p:cNvSpPr/>
          <p:nvPr/>
        </p:nvSpPr>
        <p:spPr>
          <a:xfrm>
            <a:off x="2305080" y="17928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Nuclear-Nrf2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3" name="文本框 23"/>
          <p:cNvSpPr/>
          <p:nvPr/>
        </p:nvSpPr>
        <p:spPr>
          <a:xfrm rot="18871200">
            <a:off x="2074320" y="5451120"/>
            <a:ext cx="70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4" name="文本框 24"/>
          <p:cNvSpPr/>
          <p:nvPr/>
        </p:nvSpPr>
        <p:spPr>
          <a:xfrm rot="18871200">
            <a:off x="2303280" y="5472000"/>
            <a:ext cx="843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PBS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5" name="文本框 25"/>
          <p:cNvSpPr/>
          <p:nvPr/>
        </p:nvSpPr>
        <p:spPr>
          <a:xfrm rot="18871200">
            <a:off x="2464920" y="5484960"/>
            <a:ext cx="968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6" name="文本框 26"/>
          <p:cNvSpPr/>
          <p:nvPr/>
        </p:nvSpPr>
        <p:spPr>
          <a:xfrm rot="18871200">
            <a:off x="2549520" y="553752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ML385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7" name="文本框 27"/>
          <p:cNvSpPr/>
          <p:nvPr/>
        </p:nvSpPr>
        <p:spPr>
          <a:xfrm rot="18871200">
            <a:off x="4193640" y="5451120"/>
            <a:ext cx="70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8" name="文本框 28"/>
          <p:cNvSpPr/>
          <p:nvPr/>
        </p:nvSpPr>
        <p:spPr>
          <a:xfrm rot="18871200">
            <a:off x="4422600" y="5472000"/>
            <a:ext cx="843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PBS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9" name="文本框 29"/>
          <p:cNvSpPr/>
          <p:nvPr/>
        </p:nvSpPr>
        <p:spPr>
          <a:xfrm rot="18871200">
            <a:off x="4584240" y="5484960"/>
            <a:ext cx="968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0" name="文本框 30"/>
          <p:cNvSpPr/>
          <p:nvPr/>
        </p:nvSpPr>
        <p:spPr>
          <a:xfrm rot="18871200">
            <a:off x="4668840" y="553752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ML385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1" name="文本框 23"/>
          <p:cNvSpPr/>
          <p:nvPr/>
        </p:nvSpPr>
        <p:spPr>
          <a:xfrm rot="18871200">
            <a:off x="6357600" y="5298840"/>
            <a:ext cx="70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2" name="文本框 24"/>
          <p:cNvSpPr/>
          <p:nvPr/>
        </p:nvSpPr>
        <p:spPr>
          <a:xfrm rot="18871200">
            <a:off x="6586920" y="5319360"/>
            <a:ext cx="842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PBS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3" name="文本框 25"/>
          <p:cNvSpPr/>
          <p:nvPr/>
        </p:nvSpPr>
        <p:spPr>
          <a:xfrm rot="18871200">
            <a:off x="6747480" y="5333040"/>
            <a:ext cx="968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4" name="文本框 26"/>
          <p:cNvSpPr/>
          <p:nvPr/>
        </p:nvSpPr>
        <p:spPr>
          <a:xfrm rot="18871200">
            <a:off x="6832800" y="538524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ML385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5" name="文本框 23"/>
          <p:cNvSpPr/>
          <p:nvPr/>
        </p:nvSpPr>
        <p:spPr>
          <a:xfrm rot="18871200">
            <a:off x="1953720" y="3528720"/>
            <a:ext cx="70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6" name="文本框 24"/>
          <p:cNvSpPr/>
          <p:nvPr/>
        </p:nvSpPr>
        <p:spPr>
          <a:xfrm rot="18871200">
            <a:off x="2182680" y="3549600"/>
            <a:ext cx="843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PBS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7" name="文本框 25"/>
          <p:cNvSpPr/>
          <p:nvPr/>
        </p:nvSpPr>
        <p:spPr>
          <a:xfrm rot="18871200">
            <a:off x="2343960" y="3562920"/>
            <a:ext cx="968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8" name="文本框 26"/>
          <p:cNvSpPr/>
          <p:nvPr/>
        </p:nvSpPr>
        <p:spPr>
          <a:xfrm rot="18871200">
            <a:off x="2428920" y="361512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ML385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9" name="文本框 23"/>
          <p:cNvSpPr/>
          <p:nvPr/>
        </p:nvSpPr>
        <p:spPr>
          <a:xfrm rot="18871200">
            <a:off x="4115880" y="3427920"/>
            <a:ext cx="70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0" name="文本框 24"/>
          <p:cNvSpPr/>
          <p:nvPr/>
        </p:nvSpPr>
        <p:spPr>
          <a:xfrm rot="18871200">
            <a:off x="4345200" y="3447360"/>
            <a:ext cx="842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PBS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1" name="文本框 25"/>
          <p:cNvSpPr/>
          <p:nvPr/>
        </p:nvSpPr>
        <p:spPr>
          <a:xfrm rot="18871200">
            <a:off x="4504680" y="3460680"/>
            <a:ext cx="968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2" name="文本框 26"/>
          <p:cNvSpPr/>
          <p:nvPr/>
        </p:nvSpPr>
        <p:spPr>
          <a:xfrm rot="18871200">
            <a:off x="4591080" y="351432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ML385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3" name="文本框 23"/>
          <p:cNvSpPr/>
          <p:nvPr/>
        </p:nvSpPr>
        <p:spPr>
          <a:xfrm rot="18871200">
            <a:off x="6365520" y="3427920"/>
            <a:ext cx="70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4" name="文本框 24"/>
          <p:cNvSpPr/>
          <p:nvPr/>
        </p:nvSpPr>
        <p:spPr>
          <a:xfrm rot="18871200">
            <a:off x="6593760" y="3447000"/>
            <a:ext cx="842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PBS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5" name="文本框 25"/>
          <p:cNvSpPr/>
          <p:nvPr/>
        </p:nvSpPr>
        <p:spPr>
          <a:xfrm rot="18871200">
            <a:off x="6753960" y="3460680"/>
            <a:ext cx="968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6" name="文本框 26"/>
          <p:cNvSpPr/>
          <p:nvPr/>
        </p:nvSpPr>
        <p:spPr>
          <a:xfrm rot="18871200">
            <a:off x="6840720" y="351432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ML385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7" name="文本框 23"/>
          <p:cNvSpPr/>
          <p:nvPr/>
        </p:nvSpPr>
        <p:spPr>
          <a:xfrm rot="18871200">
            <a:off x="1847520" y="1552320"/>
            <a:ext cx="70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8" name="文本框 24"/>
          <p:cNvSpPr/>
          <p:nvPr/>
        </p:nvSpPr>
        <p:spPr>
          <a:xfrm rot="18871200">
            <a:off x="2076120" y="1573200"/>
            <a:ext cx="843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PBS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9" name="文本框 25"/>
          <p:cNvSpPr/>
          <p:nvPr/>
        </p:nvSpPr>
        <p:spPr>
          <a:xfrm rot="18871200">
            <a:off x="2237400" y="1586520"/>
            <a:ext cx="968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0" name="文本框 26"/>
          <p:cNvSpPr/>
          <p:nvPr/>
        </p:nvSpPr>
        <p:spPr>
          <a:xfrm rot="18871200">
            <a:off x="2322720" y="163908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ML385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1" name="文本框 23"/>
          <p:cNvSpPr/>
          <p:nvPr/>
        </p:nvSpPr>
        <p:spPr>
          <a:xfrm rot="18871200">
            <a:off x="4193640" y="1326960"/>
            <a:ext cx="70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2" name="文本框 24"/>
          <p:cNvSpPr/>
          <p:nvPr/>
        </p:nvSpPr>
        <p:spPr>
          <a:xfrm rot="18871200">
            <a:off x="4423320" y="1347480"/>
            <a:ext cx="842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PBS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3" name="文本框 25"/>
          <p:cNvSpPr/>
          <p:nvPr/>
        </p:nvSpPr>
        <p:spPr>
          <a:xfrm rot="18871200">
            <a:off x="4583880" y="1361160"/>
            <a:ext cx="968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4" name="文本框 26"/>
          <p:cNvSpPr/>
          <p:nvPr/>
        </p:nvSpPr>
        <p:spPr>
          <a:xfrm rot="18871200">
            <a:off x="4668840" y="141336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ML385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5" name="文本框 23"/>
          <p:cNvSpPr/>
          <p:nvPr/>
        </p:nvSpPr>
        <p:spPr>
          <a:xfrm rot="18871200">
            <a:off x="6476400" y="1387080"/>
            <a:ext cx="70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6" name="文本框 24"/>
          <p:cNvSpPr/>
          <p:nvPr/>
        </p:nvSpPr>
        <p:spPr>
          <a:xfrm rot="18871200">
            <a:off x="6705360" y="1407960"/>
            <a:ext cx="843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PBS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7" name="文本框 25"/>
          <p:cNvSpPr/>
          <p:nvPr/>
        </p:nvSpPr>
        <p:spPr>
          <a:xfrm rot="18871200">
            <a:off x="6866640" y="1421640"/>
            <a:ext cx="968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8" name="文本框 26"/>
          <p:cNvSpPr/>
          <p:nvPr/>
        </p:nvSpPr>
        <p:spPr>
          <a:xfrm rot="18871200">
            <a:off x="6951600" y="147348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HG+Irisin+ML385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9" name="图片 69" descr=""/>
          <p:cNvPicPr/>
          <p:nvPr/>
        </p:nvPicPr>
        <p:blipFill>
          <a:blip r:embed="rId1"/>
          <a:srcRect l="19536" t="25663" r="30710" b="20297"/>
          <a:stretch/>
        </p:blipFill>
        <p:spPr>
          <a:xfrm>
            <a:off x="1714680" y="152280"/>
            <a:ext cx="1992240" cy="1765440"/>
          </a:xfrm>
          <a:prstGeom prst="rect">
            <a:avLst/>
          </a:prstGeom>
          <a:ln w="0">
            <a:noFill/>
          </a:ln>
        </p:spPr>
      </p:pic>
      <p:pic>
        <p:nvPicPr>
          <p:cNvPr id="160" name="图片 70" descr=""/>
          <p:cNvPicPr/>
          <p:nvPr/>
        </p:nvPicPr>
        <p:blipFill>
          <a:blip r:embed="rId2"/>
          <a:srcRect l="15355" t="21095" r="35365" b="25426"/>
          <a:stretch/>
        </p:blipFill>
        <p:spPr>
          <a:xfrm>
            <a:off x="3973680" y="152280"/>
            <a:ext cx="1974600" cy="1746360"/>
          </a:xfrm>
          <a:prstGeom prst="rect">
            <a:avLst/>
          </a:prstGeom>
          <a:ln w="0">
            <a:noFill/>
          </a:ln>
        </p:spPr>
      </p:pic>
      <p:pic>
        <p:nvPicPr>
          <p:cNvPr id="161" name="图片 71" descr=""/>
          <p:cNvPicPr/>
          <p:nvPr/>
        </p:nvPicPr>
        <p:blipFill>
          <a:blip r:embed="rId3"/>
          <a:srcRect l="18148" t="25102" r="32115" b="20642"/>
          <a:stretch/>
        </p:blipFill>
        <p:spPr>
          <a:xfrm>
            <a:off x="6215040" y="152280"/>
            <a:ext cx="1992240" cy="1773360"/>
          </a:xfrm>
          <a:prstGeom prst="rect">
            <a:avLst/>
          </a:prstGeom>
          <a:ln w="0">
            <a:noFill/>
          </a:ln>
        </p:spPr>
      </p:pic>
      <p:pic>
        <p:nvPicPr>
          <p:cNvPr id="162" name="图片 72" descr=""/>
          <p:cNvPicPr/>
          <p:nvPr/>
        </p:nvPicPr>
        <p:blipFill>
          <a:blip r:embed="rId4"/>
          <a:srcRect l="20520" t="29735" r="30200" b="17367"/>
          <a:stretch/>
        </p:blipFill>
        <p:spPr>
          <a:xfrm>
            <a:off x="1714680" y="2187720"/>
            <a:ext cx="1974600" cy="1728720"/>
          </a:xfrm>
          <a:prstGeom prst="rect">
            <a:avLst/>
          </a:prstGeom>
          <a:ln w="0">
            <a:noFill/>
          </a:ln>
        </p:spPr>
      </p:pic>
      <p:pic>
        <p:nvPicPr>
          <p:cNvPr id="163" name="图片 73" descr=""/>
          <p:cNvPicPr/>
          <p:nvPr/>
        </p:nvPicPr>
        <p:blipFill>
          <a:blip r:embed="rId5"/>
          <a:srcRect l="25580" t="23960" r="25141" b="23142"/>
          <a:stretch/>
        </p:blipFill>
        <p:spPr>
          <a:xfrm>
            <a:off x="3973680" y="2187720"/>
            <a:ext cx="1974600" cy="1728720"/>
          </a:xfrm>
          <a:prstGeom prst="rect">
            <a:avLst/>
          </a:prstGeom>
          <a:ln w="0">
            <a:noFill/>
          </a:ln>
        </p:spPr>
      </p:pic>
      <p:pic>
        <p:nvPicPr>
          <p:cNvPr id="164" name="图片 74" descr=""/>
          <p:cNvPicPr/>
          <p:nvPr/>
        </p:nvPicPr>
        <p:blipFill>
          <a:blip r:embed="rId6"/>
          <a:srcRect l="19062" t="22818" r="31641" b="24284"/>
          <a:stretch/>
        </p:blipFill>
        <p:spPr>
          <a:xfrm>
            <a:off x="6232680" y="2187720"/>
            <a:ext cx="1974600" cy="1728720"/>
          </a:xfrm>
          <a:prstGeom prst="rect">
            <a:avLst/>
          </a:prstGeom>
          <a:ln w="0">
            <a:noFill/>
          </a:ln>
        </p:spPr>
      </p:pic>
      <p:pic>
        <p:nvPicPr>
          <p:cNvPr id="165" name="图片 75" descr=""/>
          <p:cNvPicPr/>
          <p:nvPr/>
        </p:nvPicPr>
        <p:blipFill>
          <a:blip r:embed="rId7"/>
          <a:srcRect l="22839" t="24908" r="27881" b="22193"/>
          <a:stretch/>
        </p:blipFill>
        <p:spPr>
          <a:xfrm>
            <a:off x="1714680" y="4186080"/>
            <a:ext cx="1974600" cy="1727280"/>
          </a:xfrm>
          <a:prstGeom prst="rect">
            <a:avLst/>
          </a:prstGeom>
          <a:ln w="0">
            <a:noFill/>
          </a:ln>
        </p:spPr>
      </p:pic>
      <p:pic>
        <p:nvPicPr>
          <p:cNvPr id="166" name="图片 76" descr=""/>
          <p:cNvPicPr/>
          <p:nvPr/>
        </p:nvPicPr>
        <p:blipFill>
          <a:blip r:embed="rId8"/>
          <a:srcRect l="24192" t="24521" r="26528" b="22064"/>
          <a:stretch/>
        </p:blipFill>
        <p:spPr>
          <a:xfrm>
            <a:off x="3986280" y="4186080"/>
            <a:ext cx="1974960" cy="1744920"/>
          </a:xfrm>
          <a:prstGeom prst="rect">
            <a:avLst/>
          </a:prstGeom>
          <a:ln w="0">
            <a:noFill/>
          </a:ln>
        </p:spPr>
      </p:pic>
      <p:pic>
        <p:nvPicPr>
          <p:cNvPr id="167" name="图片 77" descr=""/>
          <p:cNvPicPr/>
          <p:nvPr/>
        </p:nvPicPr>
        <p:blipFill>
          <a:blip r:embed="rId9"/>
          <a:srcRect l="28145" t="25232" r="22558" b="21870"/>
          <a:stretch/>
        </p:blipFill>
        <p:spPr>
          <a:xfrm>
            <a:off x="6232680" y="4186080"/>
            <a:ext cx="1974600" cy="1727280"/>
          </a:xfrm>
          <a:prstGeom prst="rect">
            <a:avLst/>
          </a:prstGeom>
          <a:ln w="0">
            <a:noFill/>
          </a:ln>
        </p:spPr>
      </p:pic>
      <p:sp>
        <p:nvSpPr>
          <p:cNvPr id="168" name="矩形 1"/>
          <p:cNvSpPr/>
          <p:nvPr/>
        </p:nvSpPr>
        <p:spPr>
          <a:xfrm>
            <a:off x="0" y="27000"/>
            <a:ext cx="10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5D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9" name="文本框 3"/>
          <p:cNvSpPr/>
          <p:nvPr/>
        </p:nvSpPr>
        <p:spPr>
          <a:xfrm>
            <a:off x="4592520" y="428004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GSDMD-N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0" name="文本框 4"/>
          <p:cNvSpPr/>
          <p:nvPr/>
        </p:nvSpPr>
        <p:spPr>
          <a:xfrm>
            <a:off x="4592520" y="224460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NLRP3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1" name="文本框 5"/>
          <p:cNvSpPr/>
          <p:nvPr/>
        </p:nvSpPr>
        <p:spPr>
          <a:xfrm>
            <a:off x="6810480" y="2244600"/>
            <a:ext cx="91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ASC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2" name="文本框 29"/>
          <p:cNvSpPr/>
          <p:nvPr/>
        </p:nvSpPr>
        <p:spPr>
          <a:xfrm>
            <a:off x="2305080" y="428004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C-Caspase-1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3" name="文本框 7"/>
          <p:cNvSpPr/>
          <p:nvPr/>
        </p:nvSpPr>
        <p:spPr>
          <a:xfrm>
            <a:off x="6810480" y="4280040"/>
            <a:ext cx="91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4" name="文本框 8"/>
          <p:cNvSpPr/>
          <p:nvPr/>
        </p:nvSpPr>
        <p:spPr>
          <a:xfrm>
            <a:off x="2305080" y="224460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TrX1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5" name="文本框 9"/>
          <p:cNvSpPr/>
          <p:nvPr/>
        </p:nvSpPr>
        <p:spPr>
          <a:xfrm>
            <a:off x="6810480" y="210960"/>
            <a:ext cx="91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TXNIP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6" name="文本框 10"/>
          <p:cNvSpPr/>
          <p:nvPr/>
        </p:nvSpPr>
        <p:spPr>
          <a:xfrm>
            <a:off x="4592520" y="21096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Lamin B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7" name="文本框 11"/>
          <p:cNvSpPr/>
          <p:nvPr/>
        </p:nvSpPr>
        <p:spPr>
          <a:xfrm>
            <a:off x="2305080" y="179280"/>
            <a:ext cx="92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Nuclear-Nrf2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  <p:grpSp>
        <p:nvGrpSpPr>
          <p:cNvPr id="178" name="组合 2"/>
          <p:cNvGrpSpPr/>
          <p:nvPr/>
        </p:nvGrpSpPr>
        <p:grpSpPr>
          <a:xfrm>
            <a:off x="1846080" y="968760"/>
            <a:ext cx="1577520" cy="942840"/>
            <a:chOff x="1846080" y="968760"/>
            <a:chExt cx="1577520" cy="942840"/>
          </a:xfrm>
        </p:grpSpPr>
        <p:sp>
          <p:nvSpPr>
            <p:cNvPr id="179" name="文本框 33"/>
            <p:cNvSpPr/>
            <p:nvPr/>
          </p:nvSpPr>
          <p:spPr>
            <a:xfrm rot="19531800">
              <a:off x="1847880" y="1158480"/>
              <a:ext cx="72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80" name="文本框 34"/>
            <p:cNvSpPr/>
            <p:nvPr/>
          </p:nvSpPr>
          <p:spPr>
            <a:xfrm rot="19531800">
              <a:off x="1996200" y="1205640"/>
              <a:ext cx="869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81" name="文本框 35"/>
            <p:cNvSpPr/>
            <p:nvPr/>
          </p:nvSpPr>
          <p:spPr>
            <a:xfrm rot="19531800">
              <a:off x="2163600" y="1329840"/>
              <a:ext cx="1309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+ Irisin +ML385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82" name="文本框 36"/>
            <p:cNvSpPr/>
            <p:nvPr/>
          </p:nvSpPr>
          <p:spPr>
            <a:xfrm rot="19531800">
              <a:off x="2139480" y="1236240"/>
              <a:ext cx="1017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 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183" name="组合 86"/>
          <p:cNvGrpSpPr/>
          <p:nvPr/>
        </p:nvGrpSpPr>
        <p:grpSpPr>
          <a:xfrm>
            <a:off x="4182480" y="1021680"/>
            <a:ext cx="1578240" cy="942840"/>
            <a:chOff x="4182480" y="1021680"/>
            <a:chExt cx="1578240" cy="942840"/>
          </a:xfrm>
        </p:grpSpPr>
        <p:sp>
          <p:nvSpPr>
            <p:cNvPr id="184" name="文本框 33"/>
            <p:cNvSpPr/>
            <p:nvPr/>
          </p:nvSpPr>
          <p:spPr>
            <a:xfrm rot="19531800">
              <a:off x="4184280" y="1211400"/>
              <a:ext cx="72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85" name="文本框 34"/>
            <p:cNvSpPr/>
            <p:nvPr/>
          </p:nvSpPr>
          <p:spPr>
            <a:xfrm rot="19531800">
              <a:off x="4332600" y="1258200"/>
              <a:ext cx="86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86" name="文本框 35"/>
            <p:cNvSpPr/>
            <p:nvPr/>
          </p:nvSpPr>
          <p:spPr>
            <a:xfrm rot="19531800">
              <a:off x="4500360" y="1382760"/>
              <a:ext cx="1310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+ Irisin +ML385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87" name="文本框 36"/>
            <p:cNvSpPr/>
            <p:nvPr/>
          </p:nvSpPr>
          <p:spPr>
            <a:xfrm rot="19531800">
              <a:off x="4476240" y="1289160"/>
              <a:ext cx="1017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 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188" name="组合 91"/>
          <p:cNvGrpSpPr/>
          <p:nvPr/>
        </p:nvGrpSpPr>
        <p:grpSpPr>
          <a:xfrm>
            <a:off x="1796400" y="3038040"/>
            <a:ext cx="1576440" cy="942120"/>
            <a:chOff x="1796400" y="3038040"/>
            <a:chExt cx="1576440" cy="942120"/>
          </a:xfrm>
        </p:grpSpPr>
        <p:sp>
          <p:nvSpPr>
            <p:cNvPr id="189" name="文本框 33"/>
            <p:cNvSpPr/>
            <p:nvPr/>
          </p:nvSpPr>
          <p:spPr>
            <a:xfrm rot="19531800">
              <a:off x="1798200" y="3227040"/>
              <a:ext cx="721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90" name="文本框 34"/>
            <p:cNvSpPr/>
            <p:nvPr/>
          </p:nvSpPr>
          <p:spPr>
            <a:xfrm rot="19531800">
              <a:off x="1946520" y="3274200"/>
              <a:ext cx="86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91" name="文本框 35"/>
            <p:cNvSpPr/>
            <p:nvPr/>
          </p:nvSpPr>
          <p:spPr>
            <a:xfrm rot="19531800">
              <a:off x="2113560" y="3398760"/>
              <a:ext cx="1308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+ Irisin +ML385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92" name="文本框 36"/>
            <p:cNvSpPr/>
            <p:nvPr/>
          </p:nvSpPr>
          <p:spPr>
            <a:xfrm rot="19531800">
              <a:off x="2089440" y="3305160"/>
              <a:ext cx="1016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 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193" name="组合 96"/>
          <p:cNvGrpSpPr/>
          <p:nvPr/>
        </p:nvGrpSpPr>
        <p:grpSpPr>
          <a:xfrm>
            <a:off x="4085640" y="3139200"/>
            <a:ext cx="1578240" cy="942840"/>
            <a:chOff x="4085640" y="3139200"/>
            <a:chExt cx="1578240" cy="942840"/>
          </a:xfrm>
        </p:grpSpPr>
        <p:sp>
          <p:nvSpPr>
            <p:cNvPr id="194" name="文本框 33"/>
            <p:cNvSpPr/>
            <p:nvPr/>
          </p:nvSpPr>
          <p:spPr>
            <a:xfrm rot="19531800">
              <a:off x="4087440" y="3328920"/>
              <a:ext cx="72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95" name="文本框 34"/>
            <p:cNvSpPr/>
            <p:nvPr/>
          </p:nvSpPr>
          <p:spPr>
            <a:xfrm rot="19531800">
              <a:off x="4235760" y="3375720"/>
              <a:ext cx="86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96" name="文本框 35"/>
            <p:cNvSpPr/>
            <p:nvPr/>
          </p:nvSpPr>
          <p:spPr>
            <a:xfrm rot="19531800">
              <a:off x="4403520" y="3500280"/>
              <a:ext cx="1310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+ Irisin +ML385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97" name="文本框 36"/>
            <p:cNvSpPr/>
            <p:nvPr/>
          </p:nvSpPr>
          <p:spPr>
            <a:xfrm rot="19531800">
              <a:off x="4379400" y="3406680"/>
              <a:ext cx="1017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 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198" name="组合 101"/>
          <p:cNvGrpSpPr/>
          <p:nvPr/>
        </p:nvGrpSpPr>
        <p:grpSpPr>
          <a:xfrm>
            <a:off x="6264000" y="1137600"/>
            <a:ext cx="1576440" cy="941760"/>
            <a:chOff x="6264000" y="1137600"/>
            <a:chExt cx="1576440" cy="941760"/>
          </a:xfrm>
        </p:grpSpPr>
        <p:sp>
          <p:nvSpPr>
            <p:cNvPr id="199" name="文本框 33"/>
            <p:cNvSpPr/>
            <p:nvPr/>
          </p:nvSpPr>
          <p:spPr>
            <a:xfrm rot="19531800">
              <a:off x="6265800" y="1326960"/>
              <a:ext cx="721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00" name="文本框 34"/>
            <p:cNvSpPr/>
            <p:nvPr/>
          </p:nvSpPr>
          <p:spPr>
            <a:xfrm rot="19531800">
              <a:off x="6414120" y="1373760"/>
              <a:ext cx="86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01" name="文本框 35"/>
            <p:cNvSpPr/>
            <p:nvPr/>
          </p:nvSpPr>
          <p:spPr>
            <a:xfrm rot="19531800">
              <a:off x="6581160" y="1497960"/>
              <a:ext cx="1308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+ Irisin +ML385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02" name="文本框 36"/>
            <p:cNvSpPr/>
            <p:nvPr/>
          </p:nvSpPr>
          <p:spPr>
            <a:xfrm rot="19531800">
              <a:off x="6557040" y="1404720"/>
              <a:ext cx="1016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 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203" name="组合 106"/>
          <p:cNvGrpSpPr/>
          <p:nvPr/>
        </p:nvGrpSpPr>
        <p:grpSpPr>
          <a:xfrm>
            <a:off x="6449760" y="3100680"/>
            <a:ext cx="1577880" cy="942840"/>
            <a:chOff x="6449760" y="3100680"/>
            <a:chExt cx="1577880" cy="942840"/>
          </a:xfrm>
        </p:grpSpPr>
        <p:sp>
          <p:nvSpPr>
            <p:cNvPr id="204" name="文本框 33"/>
            <p:cNvSpPr/>
            <p:nvPr/>
          </p:nvSpPr>
          <p:spPr>
            <a:xfrm rot="19531800">
              <a:off x="6451560" y="3290400"/>
              <a:ext cx="72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05" name="文本框 34"/>
            <p:cNvSpPr/>
            <p:nvPr/>
          </p:nvSpPr>
          <p:spPr>
            <a:xfrm rot="19531800">
              <a:off x="6599880" y="3337200"/>
              <a:ext cx="86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06" name="文本框 35"/>
            <p:cNvSpPr/>
            <p:nvPr/>
          </p:nvSpPr>
          <p:spPr>
            <a:xfrm rot="19531800">
              <a:off x="6767280" y="3461760"/>
              <a:ext cx="1310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+ Irisin +ML385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07" name="文本框 36"/>
            <p:cNvSpPr/>
            <p:nvPr/>
          </p:nvSpPr>
          <p:spPr>
            <a:xfrm rot="19531800">
              <a:off x="6743160" y="3368160"/>
              <a:ext cx="1017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 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208" name="组合 111"/>
          <p:cNvGrpSpPr/>
          <p:nvPr/>
        </p:nvGrpSpPr>
        <p:grpSpPr>
          <a:xfrm>
            <a:off x="1896480" y="5077440"/>
            <a:ext cx="1578240" cy="943200"/>
            <a:chOff x="1896480" y="5077440"/>
            <a:chExt cx="1578240" cy="943200"/>
          </a:xfrm>
        </p:grpSpPr>
        <p:sp>
          <p:nvSpPr>
            <p:cNvPr id="209" name="文本框 33"/>
            <p:cNvSpPr/>
            <p:nvPr/>
          </p:nvSpPr>
          <p:spPr>
            <a:xfrm rot="19531800">
              <a:off x="1898280" y="5267160"/>
              <a:ext cx="72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10" name="文本框 34"/>
            <p:cNvSpPr/>
            <p:nvPr/>
          </p:nvSpPr>
          <p:spPr>
            <a:xfrm rot="19531800">
              <a:off x="2046600" y="5313960"/>
              <a:ext cx="86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11" name="文本框 35"/>
            <p:cNvSpPr/>
            <p:nvPr/>
          </p:nvSpPr>
          <p:spPr>
            <a:xfrm rot="19531800">
              <a:off x="2214360" y="5438880"/>
              <a:ext cx="1310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+ Irisin +ML385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12" name="文本框 36"/>
            <p:cNvSpPr/>
            <p:nvPr/>
          </p:nvSpPr>
          <p:spPr>
            <a:xfrm rot="19531800">
              <a:off x="2190240" y="5344920"/>
              <a:ext cx="1017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 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213" name="组合 116"/>
          <p:cNvGrpSpPr/>
          <p:nvPr/>
        </p:nvGrpSpPr>
        <p:grpSpPr>
          <a:xfrm>
            <a:off x="4043160" y="5039280"/>
            <a:ext cx="1577880" cy="942480"/>
            <a:chOff x="4043160" y="5039280"/>
            <a:chExt cx="1577880" cy="942480"/>
          </a:xfrm>
        </p:grpSpPr>
        <p:sp>
          <p:nvSpPr>
            <p:cNvPr id="214" name="文本框 33"/>
            <p:cNvSpPr/>
            <p:nvPr/>
          </p:nvSpPr>
          <p:spPr>
            <a:xfrm rot="19531800">
              <a:off x="4044960" y="5229000"/>
              <a:ext cx="72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15" name="文本框 34"/>
            <p:cNvSpPr/>
            <p:nvPr/>
          </p:nvSpPr>
          <p:spPr>
            <a:xfrm rot="19531800">
              <a:off x="4193280" y="5275800"/>
              <a:ext cx="86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16" name="文本框 35"/>
            <p:cNvSpPr/>
            <p:nvPr/>
          </p:nvSpPr>
          <p:spPr>
            <a:xfrm rot="19531800">
              <a:off x="4360680" y="5400000"/>
              <a:ext cx="1310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+ Irisin +ML385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17" name="文本框 36"/>
            <p:cNvSpPr/>
            <p:nvPr/>
          </p:nvSpPr>
          <p:spPr>
            <a:xfrm rot="19531800">
              <a:off x="4336560" y="5306760"/>
              <a:ext cx="1017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 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218" name="组合 121"/>
          <p:cNvGrpSpPr/>
          <p:nvPr/>
        </p:nvGrpSpPr>
        <p:grpSpPr>
          <a:xfrm>
            <a:off x="6332400" y="5075640"/>
            <a:ext cx="1577520" cy="942840"/>
            <a:chOff x="6332400" y="5075640"/>
            <a:chExt cx="1577520" cy="942840"/>
          </a:xfrm>
        </p:grpSpPr>
        <p:sp>
          <p:nvSpPr>
            <p:cNvPr id="219" name="文本框 33"/>
            <p:cNvSpPr/>
            <p:nvPr/>
          </p:nvSpPr>
          <p:spPr>
            <a:xfrm rot="19531800">
              <a:off x="6334200" y="5265360"/>
              <a:ext cx="72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20" name="文本框 34"/>
            <p:cNvSpPr/>
            <p:nvPr/>
          </p:nvSpPr>
          <p:spPr>
            <a:xfrm rot="19531800">
              <a:off x="6482520" y="5312520"/>
              <a:ext cx="869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PBS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21" name="文本框 35"/>
            <p:cNvSpPr/>
            <p:nvPr/>
          </p:nvSpPr>
          <p:spPr>
            <a:xfrm rot="19531800">
              <a:off x="6649920" y="5436720"/>
              <a:ext cx="1309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+ Irisin +ML385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222" name="文本框 36"/>
            <p:cNvSpPr/>
            <p:nvPr/>
          </p:nvSpPr>
          <p:spPr>
            <a:xfrm rot="19531800">
              <a:off x="6625800" y="5343120"/>
              <a:ext cx="1017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odel + Irisin</a:t>
              </a:r>
              <a:endParaRPr b="0" lang="en-US" sz="9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9-15T08:06:41Z</dcterms:created>
  <dc:creator>L</dc:creator>
  <dc:description/>
  <dc:language>en-US</dc:language>
  <cp:lastModifiedBy>Administrator</cp:lastModifiedBy>
  <dcterms:modified xsi:type="dcterms:W3CDTF">2023-11-02T14:34:42Z</dcterms:modified>
  <cp:revision>15</cp:revision>
  <dc:subject/>
  <dc:title>PowerPoint 演示文稿</dc:title>
</cp:coreProperties>
</file>